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0D94F-8D42-4561-A890-0EA809D389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AF580-C0EB-4EC7-BECD-71C6E93433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D7145-9C91-411D-9083-BC5D002CC09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775CC-7033-450B-8318-88F0E5DF26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839A9C-BC89-49A2-A61A-3014639E16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57EEB-AAC8-4C35-8EF5-DF27A30F7C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5EE81-F03B-43AE-A362-6976FFB851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0E0FF-B864-46C1-9410-DF850D2F77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53C02-1F5C-4F99-A9FA-B6DFEC0C06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1D4AB-75CB-4AE1-AAB4-FC9DDAF698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6EBB12-4D67-438F-924B-2B00A8BEF8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AF637-48C5-4D2D-A3D4-DC89E7AA0C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CA2E7E-F7A3-4C6F-9EB5-DDDCB25C091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33520" y="876240"/>
            <a:ext cx="3352680" cy="2552400"/>
            <a:chOff x="533520" y="876240"/>
            <a:chExt cx="3352680" cy="2552400"/>
          </a:xfrm>
        </p:grpSpPr>
        <p:sp>
          <p:nvSpPr>
            <p:cNvPr id="42" name=""/>
            <p:cNvSpPr/>
            <p:nvPr/>
          </p:nvSpPr>
          <p:spPr>
            <a:xfrm>
              <a:off x="1677960" y="1701720"/>
              <a:ext cx="1254240" cy="123192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992240" y="1219320"/>
              <a:ext cx="1254240" cy="123192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325520" y="1219320"/>
              <a:ext cx="1254240" cy="123192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"/>
            <p:cNvGrpSpPr/>
            <p:nvPr/>
          </p:nvGrpSpPr>
          <p:grpSpPr>
            <a:xfrm>
              <a:off x="1747800" y="2118240"/>
              <a:ext cx="1130400" cy="278280"/>
              <a:chOff x="1747800" y="2118240"/>
              <a:chExt cx="1130400" cy="278280"/>
            </a:xfrm>
          </p:grpSpPr>
          <p:sp>
            <p:nvSpPr>
              <p:cNvPr id="46" name=""/>
              <p:cNvSpPr/>
              <p:nvPr/>
            </p:nvSpPr>
            <p:spPr>
              <a:xfrm>
                <a:off x="1747800" y="212004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476440" y="211824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"/>
            <p:cNvGrpSpPr/>
            <p:nvPr/>
          </p:nvGrpSpPr>
          <p:grpSpPr>
            <a:xfrm>
              <a:off x="1373400" y="1575720"/>
              <a:ext cx="1852920" cy="276480"/>
              <a:chOff x="1373400" y="1575720"/>
              <a:chExt cx="1852920" cy="276480"/>
            </a:xfrm>
          </p:grpSpPr>
          <p:sp>
            <p:nvSpPr>
              <p:cNvPr id="49" name=""/>
              <p:cNvSpPr/>
              <p:nvPr/>
            </p:nvSpPr>
            <p:spPr>
              <a:xfrm>
                <a:off x="1373400" y="157572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739240" y="1575720"/>
                <a:ext cx="48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3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1" name=""/>
            <p:cNvSpPr/>
            <p:nvPr/>
          </p:nvSpPr>
          <p:spPr>
            <a:xfrm>
              <a:off x="2097000" y="2525040"/>
              <a:ext cx="401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994040" y="1875600"/>
              <a:ext cx="60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58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054880" y="142020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5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33520" y="876240"/>
              <a:ext cx="1676160" cy="49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Caenorhabditis spp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75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514600" y="876240"/>
              <a:ext cx="1371600" cy="49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Other Nematoda (97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066680" y="2933640"/>
              <a:ext cx="2427480" cy="49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n-Nematod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61%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"/>
          <p:cNvGrpSpPr/>
          <p:nvPr/>
        </p:nvGrpSpPr>
        <p:grpSpPr>
          <a:xfrm>
            <a:off x="533520" y="4152960"/>
            <a:ext cx="3352680" cy="2552400"/>
            <a:chOff x="533520" y="4152960"/>
            <a:chExt cx="3352680" cy="2552400"/>
          </a:xfrm>
        </p:grpSpPr>
        <p:sp>
          <p:nvSpPr>
            <p:cNvPr id="58" name=""/>
            <p:cNvSpPr/>
            <p:nvPr/>
          </p:nvSpPr>
          <p:spPr>
            <a:xfrm>
              <a:off x="1677960" y="4978440"/>
              <a:ext cx="1254240" cy="123192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992240" y="4495680"/>
              <a:ext cx="1254240" cy="123192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325520" y="4495680"/>
              <a:ext cx="1254240" cy="1231920"/>
            </a:xfrm>
            <a:prstGeom prst="ellipse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"/>
            <p:cNvGrpSpPr/>
            <p:nvPr/>
          </p:nvGrpSpPr>
          <p:grpSpPr>
            <a:xfrm>
              <a:off x="1747800" y="5394960"/>
              <a:ext cx="1131840" cy="278280"/>
              <a:chOff x="1747800" y="5394960"/>
              <a:chExt cx="1131840" cy="278280"/>
            </a:xfrm>
          </p:grpSpPr>
          <p:sp>
            <p:nvSpPr>
              <p:cNvPr id="62" name=""/>
              <p:cNvSpPr/>
              <p:nvPr/>
            </p:nvSpPr>
            <p:spPr>
              <a:xfrm>
                <a:off x="1747800" y="539676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477880" y="539496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" name=""/>
            <p:cNvGrpSpPr/>
            <p:nvPr/>
          </p:nvGrpSpPr>
          <p:grpSpPr>
            <a:xfrm>
              <a:off x="1373400" y="4852080"/>
              <a:ext cx="1854360" cy="276480"/>
              <a:chOff x="1373400" y="4852080"/>
              <a:chExt cx="1854360" cy="276480"/>
            </a:xfrm>
          </p:grpSpPr>
          <p:sp>
            <p:nvSpPr>
              <p:cNvPr id="65" name=""/>
              <p:cNvSpPr/>
              <p:nvPr/>
            </p:nvSpPr>
            <p:spPr>
              <a:xfrm>
                <a:off x="1373400" y="4852080"/>
                <a:ext cx="4017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740680" y="4852080"/>
                <a:ext cx="487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1%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7" name=""/>
            <p:cNvSpPr/>
            <p:nvPr/>
          </p:nvSpPr>
          <p:spPr>
            <a:xfrm>
              <a:off x="2052720" y="5801400"/>
              <a:ext cx="48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&lt;1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994040" y="5134680"/>
              <a:ext cx="60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62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054880" y="4696560"/>
              <a:ext cx="48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4%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33520" y="4152960"/>
              <a:ext cx="1676160" cy="49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Caenorhabditis spp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78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514600" y="4152960"/>
              <a:ext cx="1371600" cy="49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Other Nematoda (98%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066680" y="6210360"/>
              <a:ext cx="2427480" cy="49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n-Nematod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64%)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"/>
          <p:cNvSpPr/>
          <p:nvPr/>
        </p:nvSpPr>
        <p:spPr>
          <a:xfrm>
            <a:off x="1066680" y="3759120"/>
            <a:ext cx="2362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H. contortu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233360" y="457200"/>
            <a:ext cx="2030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A. suu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13T16:02:05Z</dcterms:created>
  <dc:creator>Yong Yin</dc:creator>
  <dc:description/>
  <dc:language>en-US</dc:language>
  <cp:lastModifiedBy>Yong Yin</cp:lastModifiedBy>
  <dcterms:modified xsi:type="dcterms:W3CDTF">2008-07-02T03:58:40Z</dcterms:modified>
  <cp:revision>14</cp:revision>
  <dc:subject/>
  <dc:title>PowerPoint Presentation</dc:title>
</cp:coreProperties>
</file>